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CDAB68-D020-ADDC-3BBC-3ACFF592DD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89D3E6-9AC8-72E4-C8DE-CA50C52AB9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14D51E-E4B9-E72A-6B32-9C9CEC13D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6B54A-8C63-4694-B21E-66A3B027B2E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B18409-CD13-7C90-0839-6B62745F6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F5D986-86BF-7F17-61C7-EEFBFD245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09EDD-7113-485E-B6B0-B282AF74F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349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10D212-A80F-27D5-1511-00131D58AD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F3FF71-0855-7ABA-7833-059A959A41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FBEA1B-7948-CFC7-6D48-2608E6AD6D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6B54A-8C63-4694-B21E-66A3B027B2E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69545E-B42B-0917-9FCE-B5E4EE197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ED2DB8-5615-F56D-4122-474EA05C7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09EDD-7113-485E-B6B0-B282AF74F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90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C430969-4707-F1CC-2C14-658BBD24BD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382B9E-1308-EDC0-05B7-ADFC065A72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AC461D-88D4-2830-BBAA-5845D0D0D2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6B54A-8C63-4694-B21E-66A3B027B2E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153A6F-65F6-6C4A-C61B-BDAF6B7CE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8C0B9E-7DBB-B6D7-74C5-96006C4822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09EDD-7113-485E-B6B0-B282AF74F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552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033C6F-A3DA-6C6B-50DE-FCB1D90DD0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8B8FAF-75F6-9AC5-9DF0-EB805A5DDA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8A80D9-7211-C550-F74E-1D30E2A9BF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6B54A-8C63-4694-B21E-66A3B027B2E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74BD70-04DC-9E5B-EBAA-E66D71179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3936A4-6628-FC50-8535-9FAE922DA9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09EDD-7113-485E-B6B0-B282AF74F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871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0792CA-03DE-AB8F-68A7-0B896D48C2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78EEE1-7928-E069-9D2C-E809436AC3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E07078-FA0C-7AA5-0E7D-12958A519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6B54A-8C63-4694-B21E-66A3B027B2E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5E683F-14F9-EADD-20F7-3A399AE06F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85311D-3D2B-B95D-56ED-568A9A608E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09EDD-7113-485E-B6B0-B282AF74F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772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BDDC10-F825-3BB1-FC1B-3740815CE5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71A4CC-69B1-8A76-87F0-2CE4DD2C77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9E0577-91D0-DF68-03C8-5FB44B6AF8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6A4615-248F-F1DD-B7B5-543E254FB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6B54A-8C63-4694-B21E-66A3B027B2E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E51D9C-1F4E-B2AC-68FF-979EC4BA5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80217F-B3AB-8A2A-4BA4-E54DBF92E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09EDD-7113-485E-B6B0-B282AF74F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112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F8D255-84F2-93DE-6746-0396F734D6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D8E10E-816B-D235-1DA8-FE82BF9941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77ED2A-BB0F-AF93-E7B3-19CFD997AD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84343D2-6993-1F02-B2DD-EC1D6D9623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0F87BC3-EFA9-AC5C-1FC0-DC7A424FF6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D70179F-96FC-A404-D09B-ADA3F4279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6B54A-8C63-4694-B21E-66A3B027B2E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09616AB-D981-A013-C8DD-DA8014F38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308707E-6847-92BF-08BF-11993DB48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09EDD-7113-485E-B6B0-B282AF74F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319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288C9A-D9DE-9140-1EE9-D428314A8B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6035D5-FEA7-1A87-BD2E-7085171C4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6B54A-8C63-4694-B21E-66A3B027B2E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942EBB-FABF-F83A-6A44-2EB658112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9B4AA9-67FE-5A59-D637-1AC64E84A0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09EDD-7113-485E-B6B0-B282AF74F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649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AAE70EB-4508-9522-642B-665B41109E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6B54A-8C63-4694-B21E-66A3B027B2E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F1B0A9-BB5D-AF0E-FE76-95FA655BC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EF7EF6-EBD7-27BC-ED97-9C5ED33C1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09EDD-7113-485E-B6B0-B282AF74F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559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50273C-5C9F-ECE2-2E7A-AF8F97473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CF0CEF-915A-C82B-C2AE-2F084DD749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141EB6-77A1-985A-ADC4-CC708DA151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3BADE3-8F2E-26D9-71C0-D96AB136A5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6B54A-8C63-4694-B21E-66A3B027B2E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E55EEE-1061-4F92-CC0F-15AD88535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CA2DF7-A8F1-5F76-FD73-15D259D12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09EDD-7113-485E-B6B0-B282AF74F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024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04AB58-12CC-8BBB-188B-69758CC0C6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513B4E8-D1CD-9EDA-AF52-823E419DC4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65D52C-E947-1D81-11BA-8AC9647E51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BC7A46-6B7E-95BB-0B86-E6412634E4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6B54A-8C63-4694-B21E-66A3B027B2E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42C661-3B8F-451C-DD46-54F36C45BE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F11497-CDDF-4130-01ED-D9B4139878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09EDD-7113-485E-B6B0-B282AF74F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872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E12F3D-AC39-2457-DDEA-4ED75F7BFE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2351FF-8574-EE16-7804-656433BE61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453BF4-3297-B4CA-F10B-1A89FC59B7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06B54A-8C63-4694-B21E-66A3B027B2E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61BC6C-4A36-8035-E0F2-0C856CC0D7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35037B-335A-14A3-FC23-BC4D84C6AD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B09EDD-7113-485E-B6B0-B282AF74F4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95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843581" y="1157048"/>
          <a:ext cx="6196449" cy="1826375"/>
        </p:xfrm>
        <a:graphic>
          <a:graphicData uri="http://schemas.openxmlformats.org/drawingml/2006/table">
            <a:tbl>
              <a:tblPr/>
              <a:tblGrid>
                <a:gridCol w="1495204">
                  <a:extLst>
                    <a:ext uri="{9D8B030D-6E8A-4147-A177-3AD203B41FA5}">
                      <a16:colId xmlns:a16="http://schemas.microsoft.com/office/drawing/2014/main" val="1732739367"/>
                    </a:ext>
                  </a:extLst>
                </a:gridCol>
                <a:gridCol w="935713">
                  <a:extLst>
                    <a:ext uri="{9D8B030D-6E8A-4147-A177-3AD203B41FA5}">
                      <a16:colId xmlns:a16="http://schemas.microsoft.com/office/drawing/2014/main" val="3648086064"/>
                    </a:ext>
                  </a:extLst>
                </a:gridCol>
                <a:gridCol w="1662544">
                  <a:extLst>
                    <a:ext uri="{9D8B030D-6E8A-4147-A177-3AD203B41FA5}">
                      <a16:colId xmlns:a16="http://schemas.microsoft.com/office/drawing/2014/main" val="1974161493"/>
                    </a:ext>
                  </a:extLst>
                </a:gridCol>
                <a:gridCol w="1051494">
                  <a:extLst>
                    <a:ext uri="{9D8B030D-6E8A-4147-A177-3AD203B41FA5}">
                      <a16:colId xmlns:a16="http://schemas.microsoft.com/office/drawing/2014/main" val="1841807450"/>
                    </a:ext>
                  </a:extLst>
                </a:gridCol>
                <a:gridCol w="1051494">
                  <a:extLst>
                    <a:ext uri="{9D8B030D-6E8A-4147-A177-3AD203B41FA5}">
                      <a16:colId xmlns:a16="http://schemas.microsoft.com/office/drawing/2014/main" val="3025430218"/>
                    </a:ext>
                  </a:extLst>
                </a:gridCol>
              </a:tblGrid>
              <a:tr h="230501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 negative control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NTC 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 statu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io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/Sex/Rac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0323837"/>
                  </a:ext>
                </a:extLst>
              </a:tr>
              <a:tr h="17855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ntrol 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0119837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/M/W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7665271"/>
                  </a:ext>
                </a:extLst>
              </a:tr>
              <a:tr h="15246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ntrol 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0216837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/M/O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9309961"/>
                  </a:ext>
                </a:extLst>
              </a:tr>
              <a:tr h="15246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 neg control 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021977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/F/W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6174362"/>
                  </a:ext>
                </a:extLst>
              </a:tr>
              <a:tr h="15246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 neg control 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33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/M/W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5323241"/>
                  </a:ext>
                </a:extLst>
              </a:tr>
              <a:tr h="15246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 neg control 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34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/M/W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2888414"/>
                  </a:ext>
                </a:extLst>
              </a:tr>
              <a:tr h="15246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 neg control 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34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/M/W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6838505"/>
                  </a:ext>
                </a:extLst>
              </a:tr>
              <a:tr h="15246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 neg control 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0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/M/W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2423057"/>
                  </a:ext>
                </a:extLst>
              </a:tr>
              <a:tr h="15246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 neg control 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hbb50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/F/W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5998870"/>
                  </a:ext>
                </a:extLst>
              </a:tr>
              <a:tr h="152463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ntrol 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hbb57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-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/M/W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4827680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731737" y="899299"/>
            <a:ext cx="6646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5 Table. Characteristics of HIV-negative donors for proteomics and RT-qPCR analyses.</a:t>
            </a:r>
          </a:p>
        </p:txBody>
      </p:sp>
      <p:sp>
        <p:nvSpPr>
          <p:cNvPr id="6" name="Rectangle 5"/>
          <p:cNvSpPr/>
          <p:nvPr/>
        </p:nvSpPr>
        <p:spPr>
          <a:xfrm>
            <a:off x="1753924" y="3021957"/>
            <a:ext cx="653342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breviations: WM, white matter; GM, gray matter; M, male; F, female; B, black; W, white; O, others. </a:t>
            </a:r>
            <a:endParaRPr lang="en-US" sz="11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8376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6</Words>
  <Application>Microsoft Office PowerPoint</Application>
  <PresentationFormat>Widescreen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20:01:00Z</dcterms:created>
  <dcterms:modified xsi:type="dcterms:W3CDTF">2025-07-28T20:01:29Z</dcterms:modified>
</cp:coreProperties>
</file>